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354773-6E31-4AC7-BE59-D31073C173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42F34-3D03-49AE-BB3A-2464020E3D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08265-5B94-4A69-A0E9-61822C1950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CE216C-AAF7-4C45-B0DD-9035340568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9BEC2F-142C-4F65-A7FB-EEEAB107AF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188D01-7636-4AD1-9CBE-E246B8CEE6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B20B3-299A-4DB6-BFFB-FCFFA40E93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CAC53C-56C0-490C-AC86-A27DFB7A5D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AEC13F-3C89-4CB6-9367-72E6ECC7E6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285729-18D5-41AC-BE30-0C4DD76B0C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DA3011-CFDB-49C2-829A-890996732A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D11EF5-19D8-4A76-B1C8-D54ABCA97B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808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E3AF6F-87AE-47B5-84A5-797D9C250186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125360" y="1068480"/>
            <a:ext cx="6410520" cy="3103560"/>
            <a:chOff x="1125360" y="1068480"/>
            <a:chExt cx="6410520" cy="3103560"/>
          </a:xfrm>
        </p:grpSpPr>
        <p:sp>
          <p:nvSpPr>
            <p:cNvPr id="42" name=""/>
            <p:cNvSpPr/>
            <p:nvPr/>
          </p:nvSpPr>
          <p:spPr>
            <a:xfrm>
              <a:off x="1125360" y="1068480"/>
              <a:ext cx="6345000" cy="3103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125360" y="1068480"/>
              <a:ext cx="6345000" cy="3103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427040" y="3676680"/>
              <a:ext cx="595296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493640" y="3676680"/>
              <a:ext cx="1440" cy="6192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433320" y="3676680"/>
              <a:ext cx="1800" cy="6192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5373360" y="3676680"/>
              <a:ext cx="1800" cy="6192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7311600" y="3676680"/>
              <a:ext cx="1800" cy="6192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351440" y="3729240"/>
              <a:ext cx="371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ffff"/>
                  </a:solidFill>
                  <a:latin typeface="Geneva"/>
                </a:rPr>
                <a:t>conv cryp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290760" y="3729240"/>
              <a:ext cx="369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ffff"/>
                  </a:solidFill>
                  <a:latin typeface="Geneva"/>
                </a:rPr>
                <a:t>conv villus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250960" y="3729240"/>
              <a:ext cx="346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ffff"/>
                  </a:solidFill>
                  <a:latin typeface="Geneva"/>
                </a:rPr>
                <a:t>free cryp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7190640" y="3729240"/>
              <a:ext cx="345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ffff"/>
                  </a:solidFill>
                  <a:latin typeface="Geneva"/>
                </a:rPr>
                <a:t>free villus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 flipV="1">
              <a:off x="1427040" y="1191960"/>
              <a:ext cx="1440" cy="248436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 flipH="1">
              <a:off x="1393200" y="355140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 flipH="1">
              <a:off x="1393200" y="341172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 flipH="1">
              <a:off x="1393200" y="325764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 flipH="1">
              <a:off x="1393200" y="311796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 flipH="1">
              <a:off x="1393200" y="297828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 flipH="1">
              <a:off x="1368000" y="2838600"/>
              <a:ext cx="5904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 flipH="1">
              <a:off x="1393200" y="269892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 flipH="1">
              <a:off x="1393200" y="254340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 flipH="1">
              <a:off x="1393200" y="240372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 flipH="1">
              <a:off x="1393200" y="226404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 flipH="1">
              <a:off x="1393200" y="2124000"/>
              <a:ext cx="3348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 flipH="1">
              <a:off x="1393200" y="1984320"/>
              <a:ext cx="3348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 flipH="1">
              <a:off x="1393200" y="1828800"/>
              <a:ext cx="3348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 flipH="1">
              <a:off x="1393200" y="1689120"/>
              <a:ext cx="3348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 flipH="1">
              <a:off x="1393200" y="1549440"/>
              <a:ext cx="3348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 flipH="1">
              <a:off x="1368000" y="1409760"/>
              <a:ext cx="5904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 flipH="1">
              <a:off x="1393200" y="127008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295280" y="2751120"/>
              <a:ext cx="10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ffff"/>
                  </a:solidFill>
                  <a:latin typeface="Geneva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295280" y="1324080"/>
              <a:ext cx="10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ffff"/>
                  </a:solidFill>
                  <a:latin typeface="Geneva"/>
                </a:rPr>
                <a:t>2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 flipV="1">
              <a:off x="1493640" y="1191960"/>
              <a:ext cx="1440" cy="248436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3433320" y="1191960"/>
              <a:ext cx="1800" cy="248436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 flipV="1">
              <a:off x="5373360" y="1191960"/>
              <a:ext cx="1800" cy="248436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7311600" y="1191960"/>
              <a:ext cx="1800" cy="248436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427040" y="2838600"/>
              <a:ext cx="595296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427040" y="1409760"/>
              <a:ext cx="595296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427040" y="3676680"/>
              <a:ext cx="595296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493640" y="3676680"/>
              <a:ext cx="1440" cy="6192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433320" y="3676680"/>
              <a:ext cx="1800" cy="6192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373360" y="3676680"/>
              <a:ext cx="1800" cy="6192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7311600" y="3676680"/>
              <a:ext cx="1800" cy="6192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350720" y="3729240"/>
              <a:ext cx="371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ffff"/>
                  </a:solidFill>
                  <a:latin typeface="Geneva"/>
                </a:rPr>
                <a:t>conv cryp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290760" y="3729240"/>
              <a:ext cx="369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ffff"/>
                  </a:solidFill>
                  <a:latin typeface="Geneva"/>
                </a:rPr>
                <a:t>conv villus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5250960" y="3729240"/>
              <a:ext cx="346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ffff"/>
                  </a:solidFill>
                  <a:latin typeface="Geneva"/>
                </a:rPr>
                <a:t>free cryp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7190640" y="3729240"/>
              <a:ext cx="345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ffff"/>
                  </a:solidFill>
                  <a:latin typeface="Geneva"/>
                </a:rPr>
                <a:t>free villus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 flipV="1">
              <a:off x="1427040" y="1191960"/>
              <a:ext cx="1440" cy="248436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 flipH="1">
              <a:off x="1393200" y="355140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 flipH="1">
              <a:off x="1393200" y="341172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 flipH="1">
              <a:off x="1393200" y="325764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 flipH="1">
              <a:off x="1393200" y="311796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 flipH="1">
              <a:off x="1393200" y="297828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 flipH="1">
              <a:off x="1368000" y="2838600"/>
              <a:ext cx="5904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 flipH="1">
              <a:off x="1393200" y="269892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 flipH="1">
              <a:off x="1393200" y="254340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 flipH="1">
              <a:off x="1393200" y="240372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"/>
            <p:cNvSpPr/>
            <p:nvPr/>
          </p:nvSpPr>
          <p:spPr>
            <a:xfrm flipH="1">
              <a:off x="1393200" y="226404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"/>
            <p:cNvSpPr/>
            <p:nvPr/>
          </p:nvSpPr>
          <p:spPr>
            <a:xfrm flipH="1">
              <a:off x="1393200" y="2124000"/>
              <a:ext cx="3348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"/>
            <p:cNvSpPr/>
            <p:nvPr/>
          </p:nvSpPr>
          <p:spPr>
            <a:xfrm flipH="1">
              <a:off x="1393200" y="1984320"/>
              <a:ext cx="3348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"/>
            <p:cNvSpPr/>
            <p:nvPr/>
          </p:nvSpPr>
          <p:spPr>
            <a:xfrm flipH="1">
              <a:off x="1393200" y="1828800"/>
              <a:ext cx="3348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"/>
            <p:cNvSpPr/>
            <p:nvPr/>
          </p:nvSpPr>
          <p:spPr>
            <a:xfrm flipH="1">
              <a:off x="1393200" y="1689120"/>
              <a:ext cx="3348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"/>
            <p:cNvSpPr/>
            <p:nvPr/>
          </p:nvSpPr>
          <p:spPr>
            <a:xfrm flipH="1">
              <a:off x="1393200" y="1549440"/>
              <a:ext cx="3348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"/>
            <p:cNvSpPr/>
            <p:nvPr/>
          </p:nvSpPr>
          <p:spPr>
            <a:xfrm flipH="1">
              <a:off x="1368000" y="1409760"/>
              <a:ext cx="59040" cy="180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"/>
            <p:cNvSpPr/>
            <p:nvPr/>
          </p:nvSpPr>
          <p:spPr>
            <a:xfrm flipH="1">
              <a:off x="1393200" y="1270080"/>
              <a:ext cx="33480" cy="1440"/>
            </a:xfrm>
            <a:prstGeom prst="line">
              <a:avLst/>
            </a:prstGeom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1295280" y="2751120"/>
              <a:ext cx="10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ffff"/>
                  </a:solidFill>
                  <a:latin typeface="Geneva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295280" y="1324080"/>
              <a:ext cx="10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ffff"/>
                  </a:solidFill>
                  <a:latin typeface="Geneva"/>
                </a:rPr>
                <a:t>2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1501560" y="2884680"/>
              <a:ext cx="5810040" cy="744480"/>
            </a:xfrm>
            <a:custGeom>
              <a:avLst/>
              <a:gdLst/>
              <a:ahLst/>
              <a:rect l="l" t="t" r="r" b="b"/>
              <a:pathLst>
                <a:path w="3660" h="469">
                  <a:moveTo>
                    <a:pt x="0" y="0"/>
                  </a:moveTo>
                  <a:lnTo>
                    <a:pt x="1222" y="39"/>
                  </a:lnTo>
                  <a:lnTo>
                    <a:pt x="2439" y="469"/>
                  </a:lnTo>
                  <a:lnTo>
                    <a:pt x="3660" y="362"/>
                  </a:lnTo>
                </a:path>
              </a:pathLst>
            </a:custGeom>
            <a:noFill/>
            <a:ln w="25560">
              <a:solidFill>
                <a:srgbClr val="cc663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1501560" y="2387880"/>
              <a:ext cx="5810040" cy="1163520"/>
            </a:xfrm>
            <a:custGeom>
              <a:avLst/>
              <a:gdLst/>
              <a:ahLst/>
              <a:rect l="l" t="t" r="r" b="b"/>
              <a:pathLst>
                <a:path w="3660" h="733">
                  <a:moveTo>
                    <a:pt x="0" y="694"/>
                  </a:moveTo>
                  <a:lnTo>
                    <a:pt x="1222" y="733"/>
                  </a:lnTo>
                  <a:lnTo>
                    <a:pt x="2439" y="0"/>
                  </a:lnTo>
                  <a:lnTo>
                    <a:pt x="3660" y="479"/>
                  </a:lnTo>
                </a:path>
              </a:pathLst>
            </a:custGeom>
            <a:noFill/>
            <a:ln w="25560">
              <a:solidFill>
                <a:srgbClr val="3366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1501560" y="1735200"/>
              <a:ext cx="5810040" cy="1801800"/>
            </a:xfrm>
            <a:custGeom>
              <a:avLst/>
              <a:gdLst/>
              <a:ahLst/>
              <a:rect l="l" t="t" r="r" b="b"/>
              <a:pathLst>
                <a:path w="3660" h="1135">
                  <a:moveTo>
                    <a:pt x="0" y="0"/>
                  </a:moveTo>
                  <a:lnTo>
                    <a:pt x="1222" y="763"/>
                  </a:lnTo>
                  <a:lnTo>
                    <a:pt x="2439" y="157"/>
                  </a:lnTo>
                  <a:lnTo>
                    <a:pt x="3660" y="1135"/>
                  </a:lnTo>
                </a:path>
              </a:pathLst>
            </a:custGeom>
            <a:noFill/>
            <a:ln w="25560">
              <a:solidFill>
                <a:srgbClr val="8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"/>
            <p:cNvSpPr/>
            <p:nvPr/>
          </p:nvSpPr>
          <p:spPr>
            <a:xfrm flipV="1">
              <a:off x="1493640" y="1379160"/>
              <a:ext cx="1939680" cy="2048040"/>
            </a:xfrm>
            <a:prstGeom prst="line">
              <a:avLst/>
            </a:prstGeom>
            <a:ln w="25560">
              <a:solidFill>
                <a:srgbClr val="33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441600" y="1393920"/>
              <a:ext cx="3870000" cy="1893960"/>
            </a:xfrm>
            <a:custGeom>
              <a:avLst/>
              <a:gdLst/>
              <a:ahLst/>
              <a:rect l="l" t="t" r="r" b="b"/>
              <a:pathLst>
                <a:path w="2438" h="1193">
                  <a:moveTo>
                    <a:pt x="0" y="0"/>
                  </a:moveTo>
                  <a:lnTo>
                    <a:pt x="1217" y="665"/>
                  </a:lnTo>
                  <a:lnTo>
                    <a:pt x="2438" y="1193"/>
                  </a:lnTo>
                </a:path>
              </a:pathLst>
            </a:custGeom>
            <a:noFill/>
            <a:ln w="25560">
              <a:solidFill>
                <a:srgbClr val="336699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727160" y="3541680"/>
              <a:ext cx="831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1280" rIns="71280" tIns="35640" bIns="35640" anchor="t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7045200" y="3692520"/>
              <a:ext cx="360" cy="112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211200" y="3780000"/>
              <a:ext cx="733320" cy="128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6629040" y="3767400"/>
              <a:ext cx="733680" cy="128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460160" y="3802320"/>
              <a:ext cx="733320" cy="1299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5116320" y="3780000"/>
              <a:ext cx="809640" cy="185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445760" y="3767400"/>
              <a:ext cx="419400" cy="166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319040" y="3735360"/>
              <a:ext cx="914400" cy="365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157040" y="3781440"/>
              <a:ext cx="727200" cy="239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1280" rIns="71280" tIns="35640" bIns="3564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ffffff"/>
                  </a:solidFill>
                  <a:latin typeface="Arial"/>
                </a:rPr>
                <a:t>CONV-C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177720" y="3738600"/>
              <a:ext cx="659160" cy="115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3071520" y="3783240"/>
              <a:ext cx="727200" cy="239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1280" rIns="71280" tIns="35640" bIns="3564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ffffff"/>
                  </a:solidFill>
                  <a:latin typeface="Arial"/>
                </a:rPr>
                <a:t>CONV-V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966920" y="3738600"/>
              <a:ext cx="844560" cy="231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917960" y="3783240"/>
              <a:ext cx="726840" cy="239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1280" rIns="71280" tIns="35640" bIns="3564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ffffff"/>
                  </a:solidFill>
                  <a:latin typeface="Arial"/>
                </a:rPr>
                <a:t>GF-C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6995880" y="3730680"/>
              <a:ext cx="473040" cy="185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6989400" y="3781440"/>
              <a:ext cx="478080" cy="239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1280" rIns="71280" tIns="35640" bIns="3564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ffffff"/>
                  </a:solidFill>
                  <a:latin typeface="Arial"/>
                </a:rPr>
                <a:t>GF-V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28" name=""/>
          <p:cNvSpPr/>
          <p:nvPr/>
        </p:nvSpPr>
        <p:spPr>
          <a:xfrm>
            <a:off x="0" y="4303800"/>
            <a:ext cx="91440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incipal component analysis (PCA) was performed using GeneSpring software (Agilent) to reduce the number of variables in multivariate data. Patterns of gene expression profiles of 4 different conditions such as CONV crypt (C), CONV villi (V), GF-C, and GF-V were shown in 4 components. PC1 (orange, 32%) and PC2 (green, 28%) demonstrate that 60% of the variation in gene expression was due to the state of microbial colonization (treatment effect; CONV versus GF), whereas 25% of variation in gene expression (PC3, gold) was due to an epithelial compartment effect (crypt versus villi), while PC4 (blue, 15% of the variation) did not follow a distinct pattern of treatment or compartment effect indicating a possible interaction between these two factors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1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1-10-10T23:00:19Z</dcterms:created>
  <dc:creator>John Conour</dc:creator>
  <dc:description/>
  <dc:language>en-US</dc:language>
  <cp:lastModifiedBy>shankarc</cp:lastModifiedBy>
  <cp:lastPrinted>2005-04-11T20:15:25Z</cp:lastPrinted>
  <dcterms:modified xsi:type="dcterms:W3CDTF">2007-06-21T19:47:24Z</dcterms:modified>
  <cp:revision>1085</cp:revision>
  <dc:subject/>
  <dc:title>Introduction</dc:title>
</cp:coreProperties>
</file>